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25750D-75B1-40F1-A639-A30BBFB218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B732F38-D6AD-4781-98B0-F2B6BB0883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43967A-A09E-4D8D-9407-EF8CC8E57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13F1E-946E-4599-BDA8-60B94167BF2A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05B18A-818B-4BDB-A815-56AE76ECFA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9A3F02-2D71-4398-B5A8-E3FA66E7F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49276-914F-4835-9426-C27E9505E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564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696273-D0A2-4D93-AF4A-DB2501C051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ECC1F3-7E5E-4E06-BDAC-1C6620D9D1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90E459-8107-439A-ACFC-5EB0CF861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13F1E-946E-4599-BDA8-60B94167BF2A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7BC375-332D-4722-9AD9-C352410B2A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FC41D5-00BA-4F1A-A945-CCBE43B70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49276-914F-4835-9426-C27E9505E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0849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4CAA57-79F0-481C-97A9-391653428C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9E5859-C138-47E3-BA89-81C97D80CF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A9D442-77B8-4DC1-9A98-471EBFEED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13F1E-946E-4599-BDA8-60B94167BF2A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417909-A33D-4F85-92D7-0621535B9D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0F1D00-E50F-40C2-84B5-E70859611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49276-914F-4835-9426-C27E9505E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700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011DD4-000E-41FC-BDFD-13A04DD281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69E83F-0B9E-44F3-A204-39A5C659BB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00F282-E732-4CBD-AA05-D722EBE60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13F1E-946E-4599-BDA8-60B94167BF2A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778FB3-41AA-482A-8462-77DCC35F3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C65864-8605-4097-85A3-2783539649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49276-914F-4835-9426-C27E9505E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59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44234-93E4-485C-B436-8E9F41AE5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34F75A-930E-4C7A-ACF2-2C29B7F0B0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194F5A-24CB-4021-B400-5C1D18F58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13F1E-946E-4599-BDA8-60B94167BF2A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A7F0DF-607A-4E29-8E8C-797AF4317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21BACA-3C01-4BD0-A04F-A662219A3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49276-914F-4835-9426-C27E9505E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049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61A141-DE26-470A-BDA8-F8C614310E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78655D-1262-417C-8A9A-E3BDD1C5E9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F885C9-A991-4985-8771-8CC1572581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DB937B-139C-40A0-8639-B820101E7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13F1E-946E-4599-BDA8-60B94167BF2A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6FE39F-5FC7-4DA1-AE81-7520FCD99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436984-C3CC-43A2-AA0B-7EFFE90E2C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49276-914F-4835-9426-C27E9505E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60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4DCF36-25D0-4264-9527-66EDFC178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75CEAB-D845-4193-BA07-342FE212A6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0673A5-FE6C-4AF5-83E5-1B66B0238C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CA4091-E4A3-4B95-9A50-8990195A079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05E70CA-E044-41A7-A733-43CB1962CD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A84C19C-4B62-4638-ACC8-905CE98D6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13F1E-946E-4599-BDA8-60B94167BF2A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81F666F-FBF0-41E9-9252-4BD0766C9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4D16C6-061F-493C-82FA-F137C46D2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49276-914F-4835-9426-C27E9505E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798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D33910-F610-4F22-888D-F5F8D114BF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6D51FF-CFC3-4806-8935-D6D3C83C2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13F1E-946E-4599-BDA8-60B94167BF2A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EBA4EF9-13C4-4F8E-B51B-79DB0AF0A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C79A54-280A-4C2A-A68E-33BE55766C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49276-914F-4835-9426-C27E9505E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754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EAADD42-39C8-46FB-A5EF-7A224075FC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13F1E-946E-4599-BDA8-60B94167BF2A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CB30B88-C346-4998-926A-717901A14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3A0BBBD-2470-4DCD-9ABB-EF425E969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49276-914F-4835-9426-C27E9505E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236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050621-1622-47D8-9E84-3FFE9A6D6F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84F6A2-9F17-4FD2-8BE0-B56F8E6675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86C650-A397-47B1-8376-4F560AA1D6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EDA764-21D4-491B-94D8-65AB82877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13F1E-946E-4599-BDA8-60B94167BF2A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23AA27-CF78-45E7-8EFB-2D06174B99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9A8593-94F8-4CC1-9691-C08852068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49276-914F-4835-9426-C27E9505E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023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E16F3D-8431-47C6-B7C7-EFCBB08CFE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158C0A6-4DE8-4591-93B1-0DE00010AF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C2D124-4CA6-4CBC-81EF-8BB6A5D465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BC5039-FDEB-43D4-834C-96C6A8C4F6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D13F1E-946E-4599-BDA8-60B94167BF2A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2D2D03-E402-4119-A7F1-8F6FFA126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B428BE-92BF-434C-BE28-3C5AAE836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49276-914F-4835-9426-C27E9505E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609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F3F9E88-56C8-4DA2-BB19-84B5CD10B1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E54B72-0028-4FCB-B1C4-E476EB60D0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351A9B-52FF-4C40-AFE6-9660605E08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D13F1E-946E-4599-BDA8-60B94167BF2A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D8863F-C812-457D-A39B-E92699E990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EEA402-2D72-4356-8F76-F57CF74F07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E49276-914F-4835-9426-C27E9505E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6834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02A7E78-4AD7-4067-97BE-ED6B613CBEA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8296"/>
          <a:stretch/>
        </p:blipFill>
        <p:spPr>
          <a:xfrm>
            <a:off x="2611931" y="410919"/>
            <a:ext cx="2435978" cy="625964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08F95B0-0383-4BFC-9450-C18A0A3497D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7409"/>
          <a:stretch/>
        </p:blipFill>
        <p:spPr>
          <a:xfrm>
            <a:off x="5287267" y="410918"/>
            <a:ext cx="2296467" cy="625964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A38C936-5264-4881-8F44-AAFF71362BC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9313"/>
          <a:stretch/>
        </p:blipFill>
        <p:spPr>
          <a:xfrm>
            <a:off x="9479303" y="935666"/>
            <a:ext cx="2441578" cy="560626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B9436C5-ED70-4BCB-B076-6432E1E34A08}"/>
              </a:ext>
            </a:extLst>
          </p:cNvPr>
          <p:cNvSpPr txBox="1"/>
          <p:nvPr/>
        </p:nvSpPr>
        <p:spPr>
          <a:xfrm>
            <a:off x="2401552" y="2097598"/>
            <a:ext cx="353943" cy="1719618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1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urasian lineag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2414627-38A7-4F8B-8F42-5481A2AD18A1}"/>
              </a:ext>
            </a:extLst>
          </p:cNvPr>
          <p:cNvSpPr txBox="1"/>
          <p:nvPr/>
        </p:nvSpPr>
        <p:spPr>
          <a:xfrm>
            <a:off x="2401552" y="5280414"/>
            <a:ext cx="353943" cy="1719618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</a:rPr>
              <a:t>North American lineage</a:t>
            </a:r>
            <a:endParaRPr 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3BC5588-CF14-4EE7-A8A4-72A4CC115A4B}"/>
              </a:ext>
            </a:extLst>
          </p:cNvPr>
          <p:cNvSpPr txBox="1"/>
          <p:nvPr/>
        </p:nvSpPr>
        <p:spPr>
          <a:xfrm>
            <a:off x="1116181" y="129216"/>
            <a:ext cx="6550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C708030-56AF-45BB-A0E0-45EB16242487}"/>
              </a:ext>
            </a:extLst>
          </p:cNvPr>
          <p:cNvSpPr txBox="1"/>
          <p:nvPr/>
        </p:nvSpPr>
        <p:spPr>
          <a:xfrm>
            <a:off x="4992643" y="2097598"/>
            <a:ext cx="353943" cy="1719618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1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urasian lineag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497AE0E-FCFF-44C7-9189-1CC3C159B5F0}"/>
              </a:ext>
            </a:extLst>
          </p:cNvPr>
          <p:cNvSpPr txBox="1"/>
          <p:nvPr/>
        </p:nvSpPr>
        <p:spPr>
          <a:xfrm>
            <a:off x="4966010" y="5195334"/>
            <a:ext cx="353943" cy="1719618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</a:rPr>
              <a:t>North American lineage</a:t>
            </a:r>
            <a:endParaRPr 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74D1BFE-88D0-40BA-B1AE-BB0FE3488F1B}"/>
              </a:ext>
            </a:extLst>
          </p:cNvPr>
          <p:cNvSpPr txBox="1"/>
          <p:nvPr/>
        </p:nvSpPr>
        <p:spPr>
          <a:xfrm>
            <a:off x="3575129" y="129216"/>
            <a:ext cx="6550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3604BC6-11C5-4B5E-AF07-F01F8C91372D}"/>
              </a:ext>
            </a:extLst>
          </p:cNvPr>
          <p:cNvSpPr txBox="1"/>
          <p:nvPr/>
        </p:nvSpPr>
        <p:spPr>
          <a:xfrm>
            <a:off x="6196673" y="100287"/>
            <a:ext cx="6550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5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37F27DEE-C2CB-4A5C-AA6C-09F2625BC46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1903"/>
          <a:stretch/>
        </p:blipFill>
        <p:spPr>
          <a:xfrm>
            <a:off x="7616835" y="1216413"/>
            <a:ext cx="2173613" cy="3152517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051A03BC-A2D5-4498-B744-D6D4B5FF3C12}"/>
              </a:ext>
            </a:extLst>
          </p:cNvPr>
          <p:cNvSpPr txBox="1"/>
          <p:nvPr/>
        </p:nvSpPr>
        <p:spPr>
          <a:xfrm>
            <a:off x="9690473" y="1709382"/>
            <a:ext cx="353943" cy="1719618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1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urasian lineag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D55A049-D91B-466D-8AEC-BD4EA73E16DE}"/>
              </a:ext>
            </a:extLst>
          </p:cNvPr>
          <p:cNvSpPr txBox="1"/>
          <p:nvPr/>
        </p:nvSpPr>
        <p:spPr>
          <a:xfrm>
            <a:off x="9680877" y="3071741"/>
            <a:ext cx="353943" cy="1719618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</a:rPr>
              <a:t>North American lineage</a:t>
            </a:r>
            <a:endParaRPr 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C95DB4A-3A3C-4FF4-B0B9-7EAFF37D4AB3}"/>
              </a:ext>
            </a:extLst>
          </p:cNvPr>
          <p:cNvSpPr txBox="1"/>
          <p:nvPr/>
        </p:nvSpPr>
        <p:spPr>
          <a:xfrm>
            <a:off x="11858953" y="2399267"/>
            <a:ext cx="353943" cy="1719618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1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1 like lineag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7A9129A-9D16-492F-BBAB-94A5C3C88CE6}"/>
              </a:ext>
            </a:extLst>
          </p:cNvPr>
          <p:cNvSpPr txBox="1"/>
          <p:nvPr/>
        </p:nvSpPr>
        <p:spPr>
          <a:xfrm>
            <a:off x="11858954" y="5413341"/>
            <a:ext cx="353943" cy="150161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</a:rPr>
              <a:t>North American lineage</a:t>
            </a:r>
            <a:endParaRPr 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2CC16959-A4AA-4F33-8116-847BB136B14C}"/>
              </a:ext>
            </a:extLst>
          </p:cNvPr>
          <p:cNvSpPr/>
          <p:nvPr/>
        </p:nvSpPr>
        <p:spPr>
          <a:xfrm rot="5400000">
            <a:off x="7191027" y="1898872"/>
            <a:ext cx="10150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Clade 2.2.1.1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47E80557-B629-4D1B-AD39-08F6CDE216D5}"/>
              </a:ext>
            </a:extLst>
          </p:cNvPr>
          <p:cNvSpPr/>
          <p:nvPr/>
        </p:nvSpPr>
        <p:spPr>
          <a:xfrm rot="5400000">
            <a:off x="7184209" y="4248503"/>
            <a:ext cx="10150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Clade 2.2.1.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0901273-7F14-4ACA-9BDF-41EAA2A18380}"/>
              </a:ext>
            </a:extLst>
          </p:cNvPr>
          <p:cNvSpPr txBox="1"/>
          <p:nvPr/>
        </p:nvSpPr>
        <p:spPr>
          <a:xfrm>
            <a:off x="7540833" y="5446461"/>
            <a:ext cx="353943" cy="1497421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</a:rPr>
              <a:t>North American lineage</a:t>
            </a:r>
            <a:endParaRPr 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06C85D6-13E8-41C2-8B63-43B66A7F5905}"/>
              </a:ext>
            </a:extLst>
          </p:cNvPr>
          <p:cNvSpPr txBox="1"/>
          <p:nvPr/>
        </p:nvSpPr>
        <p:spPr>
          <a:xfrm>
            <a:off x="8488716" y="100287"/>
            <a:ext cx="6550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1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A16ED23-4D42-4D59-B4B9-6DFAF7DF56FC}"/>
              </a:ext>
            </a:extLst>
          </p:cNvPr>
          <p:cNvSpPr txBox="1"/>
          <p:nvPr/>
        </p:nvSpPr>
        <p:spPr>
          <a:xfrm>
            <a:off x="10392084" y="77839"/>
            <a:ext cx="6550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9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FFABC3F-ACCE-4706-AE4C-8E3C4ECC5F4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368" y="498549"/>
            <a:ext cx="2435978" cy="62302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0973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73</TotalTime>
  <Words>33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ed  Kandeil</dc:creator>
  <cp:lastModifiedBy>Ahmed  Kandeil</cp:lastModifiedBy>
  <cp:revision>9</cp:revision>
  <dcterms:created xsi:type="dcterms:W3CDTF">2018-11-18T16:17:42Z</dcterms:created>
  <dcterms:modified xsi:type="dcterms:W3CDTF">2018-11-20T21:07:00Z</dcterms:modified>
</cp:coreProperties>
</file>